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74" r:id="rId3"/>
    <p:sldId id="275" r:id="rId4"/>
    <p:sldId id="276" r:id="rId5"/>
    <p:sldId id="277" r:id="rId6"/>
    <p:sldId id="278" r:id="rId7"/>
    <p:sldId id="268" r:id="rId8"/>
    <p:sldId id="260" r:id="rId9"/>
    <p:sldId id="270" r:id="rId10"/>
    <p:sldId id="271" r:id="rId11"/>
    <p:sldId id="269" r:id="rId12"/>
    <p:sldId id="272" r:id="rId13"/>
    <p:sldId id="273" r:id="rId14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8F82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9" d="100"/>
          <a:sy n="109" d="100"/>
        </p:scale>
        <p:origin x="329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DC373-CE67-4B96-B1C4-96CCA02C8686}" type="datetimeFigureOut">
              <a:rPr lang="ko-KR" altLang="en-US" smtClean="0"/>
              <a:t>2021-06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D630E-90C9-4E6E-9B89-2FE4565E67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35664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DC373-CE67-4B96-B1C4-96CCA02C8686}" type="datetimeFigureOut">
              <a:rPr lang="ko-KR" altLang="en-US" smtClean="0"/>
              <a:t>2021-06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D630E-90C9-4E6E-9B89-2FE4565E67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87152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DC373-CE67-4B96-B1C4-96CCA02C8686}" type="datetimeFigureOut">
              <a:rPr lang="ko-KR" altLang="en-US" smtClean="0"/>
              <a:t>2021-06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D630E-90C9-4E6E-9B89-2FE4565E67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670952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DC373-CE67-4B96-B1C4-96CCA02C8686}" type="datetimeFigureOut">
              <a:rPr lang="ko-KR" altLang="en-US" smtClean="0"/>
              <a:t>2021-06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D630E-90C9-4E6E-9B89-2FE4565E67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531238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DC373-CE67-4B96-B1C4-96CCA02C8686}" type="datetimeFigureOut">
              <a:rPr lang="ko-KR" altLang="en-US" smtClean="0"/>
              <a:t>2021-06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D630E-90C9-4E6E-9B89-2FE4565E67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61739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DC373-CE67-4B96-B1C4-96CCA02C8686}" type="datetimeFigureOut">
              <a:rPr lang="ko-KR" altLang="en-US" smtClean="0"/>
              <a:t>2021-06-0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D630E-90C9-4E6E-9B89-2FE4565E67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284331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DC373-CE67-4B96-B1C4-96CCA02C8686}" type="datetimeFigureOut">
              <a:rPr lang="ko-KR" altLang="en-US" smtClean="0"/>
              <a:t>2021-06-0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D630E-90C9-4E6E-9B89-2FE4565E67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178709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DC373-CE67-4B96-B1C4-96CCA02C8686}" type="datetimeFigureOut">
              <a:rPr lang="ko-KR" altLang="en-US" smtClean="0"/>
              <a:t>2021-06-0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D630E-90C9-4E6E-9B89-2FE4565E67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873966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DC373-CE67-4B96-B1C4-96CCA02C8686}" type="datetimeFigureOut">
              <a:rPr lang="ko-KR" altLang="en-US" smtClean="0"/>
              <a:t>2021-06-0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D630E-90C9-4E6E-9B89-2FE4565E67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78105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DC373-CE67-4B96-B1C4-96CCA02C8686}" type="datetimeFigureOut">
              <a:rPr lang="ko-KR" altLang="en-US" smtClean="0"/>
              <a:t>2021-06-0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D630E-90C9-4E6E-9B89-2FE4565E67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25743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DC373-CE67-4B96-B1C4-96CCA02C8686}" type="datetimeFigureOut">
              <a:rPr lang="ko-KR" altLang="en-US" smtClean="0"/>
              <a:t>2021-06-0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D630E-90C9-4E6E-9B89-2FE4565E67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6946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0DC373-CE67-4B96-B1C4-96CCA02C8686}" type="datetimeFigureOut">
              <a:rPr lang="ko-KR" altLang="en-US" smtClean="0"/>
              <a:t>2021-06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1D630E-90C9-4E6E-9B89-2FE4565E67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61174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51520" y="332656"/>
            <a:ext cx="8424936" cy="3096344"/>
          </a:xfrm>
        </p:spPr>
        <p:txBody>
          <a:bodyPr>
            <a:noAutofit/>
          </a:bodyPr>
          <a:lstStyle/>
          <a:p>
            <a:pPr algn="l" latinLnBrk="0"/>
            <a:r>
              <a:rPr lang="ko-KR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ko-KR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ko-KR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ko-KR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ticle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abolite Profiling Reveals Distinct Modulation of Complex Metabolic Networks in Non-pigmented, Black, and Red Rice (</a:t>
            </a:r>
            <a:r>
              <a:rPr lang="en-US" altLang="ko-KR" sz="1800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yza</a:t>
            </a:r>
            <a:r>
              <a:rPr lang="en-US" altLang="ko-KR" sz="18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ativa </a:t>
            </a:r>
            <a:r>
              <a:rPr lang="en-US" altLang="ko-KR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.) Cultivars</a:t>
            </a:r>
            <a:br>
              <a:rPr lang="en-US" altLang="ko-KR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ko-KR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ko-KR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sz="12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ae </a:t>
            </a:r>
            <a:r>
              <a:rPr lang="en-US" altLang="ko-KR" sz="1200" b="1" dirty="0" err="1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Jin</a:t>
            </a:r>
            <a:r>
              <a:rPr lang="en-US" altLang="ko-KR" sz="12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Kim </a:t>
            </a:r>
            <a:r>
              <a:rPr lang="en-US" altLang="ko-KR" sz="1200" b="1" baseline="300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,</a:t>
            </a:r>
            <a:r>
              <a:rPr lang="zh-CN" altLang="ko-KR" sz="1200" b="1" baseline="300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†</a:t>
            </a:r>
            <a:r>
              <a:rPr lang="en-US" altLang="ko-KR" sz="12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So </a:t>
            </a:r>
            <a:r>
              <a:rPr lang="en-US" altLang="ko-KR" sz="1200" b="1" dirty="0" err="1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Yeon</a:t>
            </a:r>
            <a:r>
              <a:rPr lang="en-US" altLang="ko-KR" sz="12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Kim</a:t>
            </a:r>
            <a:r>
              <a:rPr lang="en-US" altLang="ko-KR" sz="1200" b="1" baseline="300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,</a:t>
            </a:r>
            <a:r>
              <a:rPr lang="zh-CN" altLang="ko-KR" sz="1200" b="1" baseline="300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†</a:t>
            </a:r>
            <a:r>
              <a:rPr lang="en-US" altLang="ko-KR" sz="12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Young </a:t>
            </a:r>
            <a:r>
              <a:rPr lang="en-US" altLang="ko-KR" sz="1200" b="1" dirty="0" err="1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Jin</a:t>
            </a:r>
            <a:r>
              <a:rPr lang="en-US" altLang="ko-KR" sz="12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Park </a:t>
            </a:r>
            <a:r>
              <a:rPr lang="en-US" altLang="ko-KR" sz="1200" b="1" baseline="300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ko-KR" sz="12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Sun-</a:t>
            </a:r>
            <a:r>
              <a:rPr lang="en-US" altLang="ko-KR" sz="1200" b="1" dirty="0" err="1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yung</a:t>
            </a:r>
            <a:r>
              <a:rPr lang="en-US" altLang="ko-KR" sz="12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Lim </a:t>
            </a:r>
            <a:r>
              <a:rPr lang="en-US" altLang="ko-KR" sz="1200" b="1" baseline="300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ko-KR" sz="12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Sun-</a:t>
            </a:r>
            <a:r>
              <a:rPr lang="en-US" altLang="ko-KR" sz="1200" b="1" dirty="0" err="1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wa</a:t>
            </a:r>
            <a:r>
              <a:rPr lang="en-US" altLang="ko-KR" sz="12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Ha </a:t>
            </a:r>
            <a:r>
              <a:rPr lang="en-US" altLang="ko-KR" sz="1200" b="1" baseline="300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3</a:t>
            </a:r>
            <a:r>
              <a:rPr lang="en-US" altLang="ko-KR" sz="12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Sang Un Park </a:t>
            </a:r>
            <a:r>
              <a:rPr lang="en-US" altLang="ko-KR" sz="1200" b="1" baseline="300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4</a:t>
            </a:r>
            <a:r>
              <a:rPr lang="en-US" altLang="ko-KR" sz="12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ko-KR" sz="1200" b="1" dirty="0" err="1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umkyu</a:t>
            </a:r>
            <a:r>
              <a:rPr lang="en-US" altLang="ko-KR" sz="12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Lee </a:t>
            </a:r>
            <a:r>
              <a:rPr lang="en-US" altLang="ko-KR" sz="1200" b="1" baseline="300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5,</a:t>
            </a:r>
            <a:r>
              <a:rPr lang="en-US" altLang="ko-KR" sz="12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*, and Jae </a:t>
            </a:r>
            <a:r>
              <a:rPr lang="en-US" altLang="ko-KR" sz="1200" b="1" dirty="0" err="1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Kwang</a:t>
            </a:r>
            <a:r>
              <a:rPr lang="en-US" altLang="ko-KR" sz="12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Kim </a:t>
            </a:r>
            <a:r>
              <a:rPr lang="en-US" altLang="ko-KR" sz="1200" b="1" baseline="300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,</a:t>
            </a:r>
            <a:r>
              <a:rPr lang="en-US" altLang="ko-KR" sz="12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*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ko-KR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ko-KR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ivision of Life Sciences, College of Life Sciences and Bioengineering, Incheon National Univ., Incheon, 22012, Republic of Korea ;  </a:t>
            </a:r>
            <a:b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91gd@inu.ac.kr (T.J.K.), aliana79@inu.ac.kr (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Y.K.),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yj2050@inu.ac.kr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Y.J.P.), kjkpj@inu.ac.kr (J.K.K.)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vision of Horticultural Biotechnology, School of Biotechnology, </a:t>
            </a:r>
            <a:r>
              <a:rPr lang="en-US" altLang="ko-K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nkyong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ational University, An-</a:t>
            </a:r>
            <a:r>
              <a:rPr lang="en-US" altLang="ko-K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ong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7579, Republic of Korea;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imsh2@hknu.ac.kr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partment of Genetic Engineering and Graduate School of Biotechnology, Kyung </a:t>
            </a:r>
            <a:r>
              <a:rPr lang="en-US" altLang="ko-K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e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niversity, </a:t>
            </a:r>
            <a:r>
              <a:rPr lang="en-US" altLang="ko-K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ongin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7104, Republic of Korea;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unhwa@khu.ac.kr</a:t>
            </a:r>
            <a:r>
              <a:rPr lang="ko-KR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ko-KR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partment of Crop Science, </a:t>
            </a:r>
            <a:r>
              <a:rPr lang="en-US" altLang="ko-K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ungnam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ational University, 99 </a:t>
            </a:r>
            <a:r>
              <a:rPr lang="en-US" altLang="ko-K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ehak-ro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useong-gu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Daejeon 34134, Republic of Korea; supark@cnu.ac.kr</a:t>
            </a:r>
            <a:b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partment of Environment Science &amp; Biotechnology, </a:t>
            </a:r>
            <a:r>
              <a:rPr lang="en-US" altLang="ko-K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eonju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niversity, </a:t>
            </a:r>
            <a:r>
              <a:rPr lang="en-US" altLang="ko-K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eonju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5069, Republic of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orea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leebk@jj.ac.kr</a:t>
            </a:r>
            <a:b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spondence: leebk@jj.ac.kr (B.L.); Tel.: +82-63-220-2227; kjkpj@inu.ac.kr (J.K.K.); Tel.: +82-32-835-8241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†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se authors contributed equally to this work.</a:t>
            </a:r>
            <a:b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ko-KR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ko-KR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en-US" altLang="ko-KR" sz="11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33772" y="3528392"/>
            <a:ext cx="8658708" cy="4005064"/>
          </a:xfrm>
        </p:spPr>
        <p:txBody>
          <a:bodyPr>
            <a:noAutofit/>
          </a:bodyPr>
          <a:lstStyle/>
          <a:p>
            <a:pPr marL="0" indent="0" algn="ctr">
              <a:buNone/>
            </a:pP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s</a:t>
            </a:r>
          </a:p>
          <a:p>
            <a:pPr marL="0" indent="0" algn="ctr">
              <a:buNone/>
            </a:pPr>
            <a:endParaRPr lang="en-US" altLang="ko-K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28600" indent="-228600">
              <a:buFont typeface="+mj-lt"/>
              <a:buAutoNum type="arabicPeriod"/>
            </a:pP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ncipal component analysis (PCA) score plots (A) and loading plots (B) derived from 110 metabolites in 16 rice cultivars. Principal component (PC) 1 and PC2 accounted for 24.2% and 15.3% of the total variance, respectively. The ellipse represents the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otelling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2 with 95% confidence in the score plot. The loading plots represent the original variables in the space of the PCs; they reveal the magnitude and direction of correlation of the original variables with the first two PCs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marL="228600" indent="-228600">
              <a:buFont typeface="+mj-lt"/>
              <a:buAutoNum type="arabicPeriod"/>
            </a:pP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mutation test by OPLS-DA of pigmented rice and non-pigmented rice (A), and black rice and red rice (B). The number of permutations for the permutation test was 200.</a:t>
            </a:r>
          </a:p>
          <a:p>
            <a:pPr marL="228600" indent="-228600">
              <a:buFont typeface="+mj-lt"/>
              <a:buAutoNum type="arabicPeriod"/>
            </a:pPr>
            <a:r>
              <a:rPr lang="en-US" altLang="ko-KR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US" altLang="ko-KR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2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.</a:t>
            </a:r>
            <a:r>
              <a:rPr lang="en-US" altLang="ko-KR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enotypes of 16 </a:t>
            </a:r>
            <a:r>
              <a:rPr lang="en-US" altLang="ko-KR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ce 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ltivars used in this study.</a:t>
            </a:r>
            <a:endParaRPr lang="en-US" altLang="ko-KR" sz="1200" kern="1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28600" indent="-228600">
              <a:buFont typeface="+mj-lt"/>
              <a:buAutoNum type="arabicPeriod"/>
            </a:pP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4.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CxGC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OF-MS analytical ion chromatogram (AIC) of hydrophilic compounds extracted from 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ongjin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DJ).</a:t>
            </a:r>
          </a:p>
          <a:p>
            <a:pPr marL="228600" indent="-228600">
              <a:buFont typeface="+mj-lt"/>
              <a:buAutoNum type="arabicPeriod"/>
            </a:pP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5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C-FID chromatogram of fatty acid compounds from Suwon 505 (SW 505). </a:t>
            </a:r>
            <a:endParaRPr lang="en-US" altLang="ko-KR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28600" indent="-228600">
              <a:buFont typeface="+mj-lt"/>
              <a:buAutoNum type="arabicPeriod"/>
            </a:pP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6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PLC chromatogram of carotenoid compounds from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ugnam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HN)..</a:t>
            </a:r>
            <a:endParaRPr lang="en-US" altLang="ko-KR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28600" indent="-228600">
              <a:buFont typeface="+mj-lt"/>
              <a:buAutoNum type="arabicPeriod"/>
            </a:pP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7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PLC chromatogram of anthocyanin compounds from 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ugjinju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HJJ). </a:t>
            </a:r>
            <a:endParaRPr lang="en-US" altLang="ko-KR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28600" indent="-228600">
              <a:buFont typeface="+mj-lt"/>
              <a:buAutoNum type="arabicPeriod"/>
            </a:pP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8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PLC chromatogram of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techin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picatechin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om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engmi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M).. </a:t>
            </a:r>
          </a:p>
          <a:p>
            <a:pPr marL="228600" indent="-228600">
              <a:buFont typeface="+mj-lt"/>
              <a:buAutoNum type="arabicPeriod"/>
            </a:pP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9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-SPME GC-TOF-MS analytical ion chromatogram of volatile compounds from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ugjinju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HJJ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  <a:p>
            <a:pPr marL="228600" indent="-228600">
              <a:buFont typeface="+mj-lt"/>
              <a:buAutoNum type="arabicPeriod"/>
            </a:pPr>
            <a:endParaRPr lang="en-US" altLang="ko-KR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25291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TextBox 100"/>
          <p:cNvSpPr txBox="1"/>
          <p:nvPr/>
        </p:nvSpPr>
        <p:spPr>
          <a:xfrm>
            <a:off x="90684" y="1340768"/>
            <a:ext cx="9000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. S6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PLC chromatogram of carotenoid compounds from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ugnam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HN). 1, Lutein; 2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eaxanthin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3, </a:t>
            </a:r>
            <a:r>
              <a:rPr lang="el-G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–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o–8'–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rotena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Internal standard); 4, </a:t>
            </a:r>
            <a:r>
              <a:rPr lang="el-G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–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rotene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516" y="2132856"/>
            <a:ext cx="9000000" cy="27822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5412426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90684" y="1340768"/>
            <a:ext cx="900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. S7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PLC chromatogram of anthocyanin compounds from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ujinju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HJJ). 1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anidin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3–O–glucoside; 2, 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onidin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–3–O–glucoside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그림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786" y="2420888"/>
            <a:ext cx="9000000" cy="27751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994786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0684" y="1556792"/>
            <a:ext cx="900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. S8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PLC chromatogram of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techin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picatechin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om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engmi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M). 1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techin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2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picatechin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684" y="2276872"/>
            <a:ext cx="9000000" cy="21048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9426590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그림 3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006349"/>
            <a:ext cx="9000000" cy="4230963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>
            <a:off x="-2559" y="764704"/>
            <a:ext cx="9000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. S9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-SPME GC-TOF-MS analytical ion chromatogram of volatile compounds from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ugjinju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HJJ). 1, 1–Butanol; 2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ntana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3, 1–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ntano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4, Toluene; 5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xana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6, 1–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xano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7, Ethylbenzene; 8, p–Xylene; 9, 2–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ptanone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10, 2–Butyl furan; 11, Styrene; 12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ptana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13, 2–Acetyl–1–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yrroline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14, </a:t>
            </a:r>
            <a:r>
              <a:rPr lang="el-G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–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inene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15, 1–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ptano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16, Benzaldehyde; 17, 1–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cten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3–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18, 2–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nty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uran; 19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ctana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20, p–Cymene; 21, D–Limonene; 22, 3–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cten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2–one; 23, </a:t>
            </a:r>
            <a:r>
              <a:rPr lang="el-G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–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rpinene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24, 1–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ctano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25, Linalool; 26, o–Cymene; 27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nana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28, 1–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nano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29, Naphthalene; 30, Decanal; 31, 1H–Indole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4185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251520" y="136076"/>
            <a:ext cx="871296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atinLnBrk="0"/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. S1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ncipal component analysis (PCA) score (A) and loading plots (B) derived from 110 metabolites of black, red, and white colored rice cultivars. Principal component (PC) 1 and PC2 accounted for 24.2% and 15.3% of the total variance, respectively. The ellipse represents the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otelling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2 with 95% confidence in the score plot.</a:t>
            </a:r>
            <a:endParaRPr lang="ko-KR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8004" y="787860"/>
            <a:ext cx="9000000" cy="52937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266383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9628" y="692696"/>
            <a:ext cx="9000000" cy="53679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538380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16024" y="332656"/>
            <a:ext cx="9127976" cy="2677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0"/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ot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notation 1, C20-ol (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icosano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; 2, C21-ol (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neicosano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; 3, C22-ol (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cosano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; 4, C24-ol (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tracosano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; 5, C26-ol (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xacosano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; 6, </a:t>
            </a:r>
            <a:r>
              <a:rPr lang="el-G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copherol ; 7, </a:t>
            </a:r>
            <a:r>
              <a:rPr lang="el-G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-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copherol ; 8, C27-ol (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ptacosano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; 9, C28-ol (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ctacosano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; 10, </a:t>
            </a:r>
            <a:r>
              <a:rPr lang="el-G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-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cotrieno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; 11, </a:t>
            </a:r>
            <a:r>
              <a:rPr lang="el-G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-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copherol ; 12, Cholesterol; 13, </a:t>
            </a:r>
            <a:r>
              <a:rPr lang="el-G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-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cotrieno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; 14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mpestero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15, C30-ol (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iacontano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; 16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igmastero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17, </a:t>
            </a:r>
            <a:r>
              <a:rPr lang="el-G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tostero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18, Lutein; 19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eaxanthin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20, </a:t>
            </a:r>
            <a:r>
              <a:rPr lang="el-G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rotene ; 21, Cyanidine-3-O-glucose; 22, Peonidine-3-O-glucose; 23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techin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24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picatechin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25, C16:0 (Palmitic acid); 26, C18:0 (Stearic acid); 27, C18:1 (Oleic acid); 28, C18:2 (Linoleic acid); 29, C18:3 (</a:t>
            </a:r>
            <a:r>
              <a:rPr lang="el-G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-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nolenic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); 30, C20:0 (Arachidonic acid); 31, Pyruvic acid; 32, Lactic acid; 33, Alanine; 34, Oxalic acid; 35, Valine; 36, Ethanolamine; 37, Leucine; 38, Glycerol; 39, Phosphoric acid; 40, Isoleucine; 41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line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42, Glycine; 43, Succinic acid; 44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umaric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; 45, Serine; 46, Threonine; 47, </a:t>
            </a:r>
            <a:r>
              <a:rPr lang="el-G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anine; 48, Malic acid; 49, Salicylic acid; 50, Methionine; 51, Aspartic acid ; 52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yroglutamic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; 53, </a:t>
            </a:r>
            <a:r>
              <a:rPr lang="el-G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-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inobutyric acid; 54, Cysteine; 55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reonic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; 56, Glutamic acid; 57, p-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droxy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enzoic acid; 58, Phenylalanine; 59, Asparagine; 60, Xylose; 61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nillic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; 62, Glutamine; 63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ocatechuic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; 64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ikimic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; 65, Citric acid; 66, Fructose; 67, Galactose; 68, Lysine; 69, Glucose; 70,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umaric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; 71, Tyrosine; 72, Mannitol; 73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rulic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; 74, Inositol; 75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ffeic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; 76, Tryptophan; 77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napinic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 ; 78, Sucrose; 79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ffinose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80, 1-Butanol; 81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ntana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82, 1-Pentanol; 83, Toluene; 84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xana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85, 1-Hexanol; 86, Ethylbenzene; 87,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Xylene; 88, 2-Heptanone; 89, 2-Butyl furan; 90, Styrene; 91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ptana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92, 2-Acetyl-1-pyrroline; 93, </a:t>
            </a:r>
            <a:r>
              <a:rPr lang="el-G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-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inene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94, 1-Heptanol; 95, Benzaldehyde; 96, 1-Octen-3-ol; 97, 2-Pentyl furan; 98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ctana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99,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ymene; 100, D-Limonene; 101, 3-Octen-2-one; 102, </a:t>
            </a:r>
            <a:r>
              <a:rPr lang="el-G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-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rpinene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103, 1-Octanol; 104, Linalool; 105, o-Cymene; 106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nana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; 107, 1-Nonanol; 108, Naphthalene; 109, Decanal; 110, 1H-Indole.</a:t>
            </a:r>
          </a:p>
        </p:txBody>
      </p:sp>
    </p:spTree>
    <p:extLst>
      <p:ext uri="{BB962C8B-B14F-4D97-AF65-F5344CB8AC3E}">
        <p14:creationId xmlns:p14="http://schemas.microsoft.com/office/powerpoint/2010/main" val="32525406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251520" y="332656"/>
            <a:ext cx="87129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. S2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mutation test by OPLS-DA of pigmented rice and non-pigmented rice (A), and black rice and red rice (B). The number of permutations for the permutation test was 200.</a:t>
            </a: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8004" y="794321"/>
            <a:ext cx="9000000" cy="56277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3506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4000" y="692696"/>
            <a:ext cx="9000000" cy="56277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077075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355556" y="188640"/>
            <a:ext cx="7860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0">
              <a:lnSpc>
                <a:spcPct val="200000"/>
              </a:lnSpc>
              <a:spcAft>
                <a:spcPts val="1000"/>
              </a:spcAft>
            </a:pPr>
            <a:r>
              <a:rPr lang="en-US" altLang="ko-KR" sz="12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3.</a:t>
            </a:r>
            <a:r>
              <a:rPr lang="en-US" altLang="ko-KR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enotypes of 16 rice cultivars used in this study.</a:t>
            </a: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5556" y="594007"/>
            <a:ext cx="6639119" cy="54320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6119605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TextBox 100"/>
          <p:cNvSpPr txBox="1"/>
          <p:nvPr/>
        </p:nvSpPr>
        <p:spPr>
          <a:xfrm>
            <a:off x="119846" y="548680"/>
            <a:ext cx="90000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. S4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CxGC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OF-MS analytical ion chromatogram (AIC) of hydrophilic compounds extracted from 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ongjin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DJ). </a:t>
            </a:r>
          </a:p>
          <a:p>
            <a:pPr algn="just"/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ak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1, Pyruvic acid; 2, Lactic acid; 3, Alanine; 4, Oxalic acid; 5, Valine; 6, Serine (1); 7, Ethanolamine; 8, Leucine; 9, Glycerol; 10, Phosphoric acid; 11, Isoleucine; 12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line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13, Glycine; 14, Succinic acid;15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yceric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; 16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umaric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; 17, Serine (2); 18, Threonine; 19, </a:t>
            </a:r>
            <a:r>
              <a:rPr lang="el-G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–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anine; 20, Malic acid; 21, Salicylic acid; 22, Methionine; 23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yroglutamic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; 24, Aspartic acid; 25, 4–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inobutytic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; 26, Cysteine; 27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reonic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; 28, Glutamic acid; 29, p–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droxybenzoic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; 30, Phenylalanine; 31, Asparagine; 32, Xylose (1); 33, Xylose (2); 34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ibito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Internal standard); 35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nillic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; 36, Glutamine; 37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ikimic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; 38, Citric acid; 39, Fructose (1); 40, Fructose (2); 41, Lysine; 42, p–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umaric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; 43, Tyrosine; 44, Mannitol; 45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rulic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; 46, Inositol; 47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ffeic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; 48, Tryptophan; 49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napinic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; 50, Sucrose; 51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ffinose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9846" y="2348880"/>
            <a:ext cx="9000000" cy="32647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6123099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TextBox 100"/>
          <p:cNvSpPr txBox="1"/>
          <p:nvPr/>
        </p:nvSpPr>
        <p:spPr>
          <a:xfrm>
            <a:off x="107504" y="1196752"/>
            <a:ext cx="9000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. S5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C-FID chromatogram of fatty acid compounds from Suwon 505 (SW 505). 1, C15:0 (Internal standard); 2. C16:0 (Palmitic acid); 3, C18:0 (Stearic acid); 4, C18:1 (Oleic acid); 5, C18:2 (Linoleic acid); 6, C18:3 (</a:t>
            </a:r>
            <a:r>
              <a:rPr lang="el-G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–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nolenic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); 7, C20:0 (Arachidonic acid)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그룹 3">
            <a:extLst>
              <a:ext uri="{FF2B5EF4-FFF2-40B4-BE49-F238E27FC236}">
                <a16:creationId xmlns:a16="http://schemas.microsoft.com/office/drawing/2014/main" id="{4BE1F5F4-3B4F-41C8-A2C4-1AFCF7C35909}"/>
              </a:ext>
            </a:extLst>
          </p:cNvPr>
          <p:cNvGrpSpPr/>
          <p:nvPr/>
        </p:nvGrpSpPr>
        <p:grpSpPr>
          <a:xfrm>
            <a:off x="107504" y="2204864"/>
            <a:ext cx="9000000" cy="2977200"/>
            <a:chOff x="714559" y="1569680"/>
            <a:chExt cx="10762879" cy="2449661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12774A43-E945-4794-80E6-ED5EB67A9A6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14559" y="1569680"/>
              <a:ext cx="10762879" cy="244966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" name="직사각형 5">
              <a:extLst>
                <a:ext uri="{FF2B5EF4-FFF2-40B4-BE49-F238E27FC236}">
                  <a16:creationId xmlns:a16="http://schemas.microsoft.com/office/drawing/2014/main" id="{8B25B6FE-F781-4BD6-9488-D44FD2E19347}"/>
                </a:ext>
              </a:extLst>
            </p:cNvPr>
            <p:cNvSpPr/>
            <p:nvPr/>
          </p:nvSpPr>
          <p:spPr>
            <a:xfrm>
              <a:off x="1045026" y="1589308"/>
              <a:ext cx="3165232" cy="9206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7B2DE9AE-EB6F-4136-9220-3C2C9D50A07F}"/>
                </a:ext>
              </a:extLst>
            </p:cNvPr>
            <p:cNvSpPr txBox="1"/>
            <p:nvPr/>
          </p:nvSpPr>
          <p:spPr>
            <a:xfrm>
              <a:off x="1609492" y="1809759"/>
              <a:ext cx="2245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F520892-ECDA-4AEC-8D49-A27043572918}"/>
                </a:ext>
              </a:extLst>
            </p:cNvPr>
            <p:cNvSpPr txBox="1"/>
            <p:nvPr/>
          </p:nvSpPr>
          <p:spPr>
            <a:xfrm>
              <a:off x="3066728" y="2403250"/>
              <a:ext cx="2245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9FB6A30-858A-4533-964B-B1E2ACAA4F7E}"/>
                </a:ext>
              </a:extLst>
            </p:cNvPr>
            <p:cNvSpPr txBox="1"/>
            <p:nvPr/>
          </p:nvSpPr>
          <p:spPr>
            <a:xfrm>
              <a:off x="6282201" y="3383485"/>
              <a:ext cx="2245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13A1C13B-0868-4FC4-ABD3-FC25A1D5A9F5}"/>
                </a:ext>
              </a:extLst>
            </p:cNvPr>
            <p:cNvSpPr txBox="1"/>
            <p:nvPr/>
          </p:nvSpPr>
          <p:spPr>
            <a:xfrm>
              <a:off x="6642206" y="2011071"/>
              <a:ext cx="2245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9BF94B5-55CD-48C6-8D2B-047EB2BB3246}"/>
                </a:ext>
              </a:extLst>
            </p:cNvPr>
            <p:cNvSpPr txBox="1"/>
            <p:nvPr/>
          </p:nvSpPr>
          <p:spPr>
            <a:xfrm>
              <a:off x="7427713" y="1755407"/>
              <a:ext cx="2245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E76626CF-332D-4322-9D87-43260758E750}"/>
                </a:ext>
              </a:extLst>
            </p:cNvPr>
            <p:cNvSpPr txBox="1"/>
            <p:nvPr/>
          </p:nvSpPr>
          <p:spPr>
            <a:xfrm>
              <a:off x="8521248" y="3429867"/>
              <a:ext cx="2245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658026AF-401E-4D18-8CED-F9E6585C6969}"/>
                </a:ext>
              </a:extLst>
            </p:cNvPr>
            <p:cNvSpPr txBox="1"/>
            <p:nvPr/>
          </p:nvSpPr>
          <p:spPr>
            <a:xfrm>
              <a:off x="10139750" y="3520701"/>
              <a:ext cx="2245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3236238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30</TotalTime>
  <Words>1465</Words>
  <Application>Microsoft Office PowerPoint</Application>
  <PresentationFormat>화면 슬라이드 쇼(4:3)</PresentationFormat>
  <Paragraphs>30</Paragraphs>
  <Slides>1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3</vt:i4>
      </vt:variant>
    </vt:vector>
  </HeadingPairs>
  <TitlesOfParts>
    <vt:vector size="19" baseType="lpstr">
      <vt:lpstr>SimSun</vt:lpstr>
      <vt:lpstr>맑은 고딕</vt:lpstr>
      <vt:lpstr>Arial</vt:lpstr>
      <vt:lpstr>Palatino Linotype</vt:lpstr>
      <vt:lpstr>Times New Roman</vt:lpstr>
      <vt:lpstr>Office 테마</vt:lpstr>
      <vt:lpstr>   Article  Metabolite Profiling Reveals Distinct Modulation of Complex Metabolic Networks in Non-pigmented, Black, and Red Rice (Oryza sativa L.) Cultivars   Tae Jin Kim 1,†, So Yeon Kim1,†, Young Jin Park 1, Sun-Hyung Lim 2, Sun-Hwa Ha 3, Sang Un Park 4, Bumkyu Lee 5,*, and Jae Kwang Kim 1,*   1 Division of Life Sciences, College of Life Sciences and Bioengineering, Incheon National Univ., Incheon, 22012, Republic of Korea ;     f91gd@inu.ac.kr (T.J.K.), aliana79@inu.ac.kr (S.Y.K.), pyj2050@inu.ac.kr (Y.J.P.), kjkpj@inu.ac.kr (J.K.K.) 2 Division of Horticultural Biotechnology, School of Biotechnology, Hankyong National University, An-seong 17579, Republic of Korea;    limsh2@hknu.ac.kr 3 Department of Genetic Engineering and Graduate School of Biotechnology, Kyung Hee University, Yongin 17104, Republic of Korea;    sunhwa@khu.ac.kr 4 Department of Crop Science, Chungnam National University, 99 Daehak-ro, Yuseong-gu, Daejeon 34134, Republic of Korea; supark@cnu.ac.kr 5 Department of Environment Science &amp; Biotechnology, Jeonju University, Jeonju 55069, Republic of Korea; leebk@jj.ac.kr  *Correspondence: leebk@jj.ac.kr (B.L.); Tel.: +82-63-220-2227; kjkpj@inu.ac.kr (J.K.K.); Tel.: +82-32-835-8241 † These authors contributed equally to this work.   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esearch papers  Metabolite profiling of pepper (Capsicum) fruits of 13 various phenotypes associated with different maturity state   Tae Jin Kima, Nam Il Parkb, and Jae Kwang Kima*  a Division of Life Sciences and Convergence Research Center for Insect Vectors, Incheon National Univ., Incheon, 22012, Republic of Korea.  b Department of Plant Science, Gangneung-Wonju National University, 7 Jukheon-gil, Gangneung, 25457, Republic of Korea.  * Corresponding author  E-mail address: kjkpj@inu.ac.kr (J.K. Kim)</dc:title>
  <dc:creator>305-2</dc:creator>
  <cp:lastModifiedBy>Windows 사용자</cp:lastModifiedBy>
  <cp:revision>101</cp:revision>
  <dcterms:created xsi:type="dcterms:W3CDTF">2019-02-14T07:18:07Z</dcterms:created>
  <dcterms:modified xsi:type="dcterms:W3CDTF">2021-06-08T23:17:44Z</dcterms:modified>
</cp:coreProperties>
</file>